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77" r:id="rId2"/>
    <p:sldId id="281" r:id="rId3"/>
    <p:sldId id="282" r:id="rId4"/>
    <p:sldId id="283" r:id="rId5"/>
    <p:sldId id="274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91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883" autoAdjust="0"/>
  </p:normalViewPr>
  <p:slideViewPr>
    <p:cSldViewPr>
      <p:cViewPr>
        <p:scale>
          <a:sx n="70" d="100"/>
          <a:sy n="70" d="100"/>
        </p:scale>
        <p:origin x="-1738" y="-355"/>
      </p:cViewPr>
      <p:guideLst>
        <p:guide orient="horz" pos="2160"/>
        <p:guide pos="29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127573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10/17 Su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hyperlink" Target="http://www.omicshare.com/tools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hyperlink" Target="http://www.omicshare.com/tools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/>
          <p:cNvGrpSpPr/>
          <p:nvPr/>
        </p:nvGrpSpPr>
        <p:grpSpPr>
          <a:xfrm>
            <a:off x="1065188" y="194632"/>
            <a:ext cx="7078980" cy="5970672"/>
            <a:chOff x="1563" y="0"/>
            <a:chExt cx="11148" cy="9963"/>
          </a:xfrm>
        </p:grpSpPr>
        <p:pic>
          <p:nvPicPr>
            <p:cNvPr id="4" name="图片 3" descr="TE_CLASS.bmp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115" y="0"/>
              <a:ext cx="8735" cy="9711"/>
            </a:xfrm>
            <a:prstGeom prst="rect">
              <a:avLst/>
            </a:prstGeom>
          </p:spPr>
        </p:pic>
        <p:grpSp>
          <p:nvGrpSpPr>
            <p:cNvPr id="69" name="组合 68"/>
            <p:cNvGrpSpPr/>
            <p:nvPr/>
          </p:nvGrpSpPr>
          <p:grpSpPr>
            <a:xfrm>
              <a:off x="1563" y="0"/>
              <a:ext cx="11148" cy="9963"/>
              <a:chOff x="992596" y="-72104"/>
              <a:chExt cx="7078991" cy="6327318"/>
            </a:xfrm>
          </p:grpSpPr>
          <p:grpSp>
            <p:nvGrpSpPr>
              <p:cNvPr id="63" name="组合 62"/>
              <p:cNvGrpSpPr/>
              <p:nvPr/>
            </p:nvGrpSpPr>
            <p:grpSpPr>
              <a:xfrm>
                <a:off x="992596" y="-72104"/>
                <a:ext cx="7078991" cy="6327318"/>
                <a:chOff x="135340" y="356524"/>
                <a:chExt cx="7078991" cy="6327318"/>
              </a:xfrm>
            </p:grpSpPr>
            <p:grpSp>
              <p:nvGrpSpPr>
                <p:cNvPr id="2" name="组合 58"/>
                <p:cNvGrpSpPr/>
                <p:nvPr/>
              </p:nvGrpSpPr>
              <p:grpSpPr>
                <a:xfrm>
                  <a:off x="135340" y="356524"/>
                  <a:ext cx="6365295" cy="6327318"/>
                  <a:chOff x="-221866" y="1713838"/>
                  <a:chExt cx="6365295" cy="6327318"/>
                </a:xfrm>
              </p:grpSpPr>
              <p:sp>
                <p:nvSpPr>
                  <p:cNvPr id="5" name="TextBox 4"/>
                  <p:cNvSpPr txBox="1"/>
                  <p:nvPr/>
                </p:nvSpPr>
                <p:spPr>
                  <a:xfrm rot="16200000">
                    <a:off x="-729637" y="2657433"/>
                    <a:ext cx="1428760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           Class I : </a:t>
                    </a:r>
                  </a:p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long terminal repeat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6" name="直接连接符 5"/>
                  <p:cNvCxnSpPr/>
                  <p:nvPr/>
                </p:nvCxnSpPr>
                <p:spPr>
                  <a:xfrm rot="16200000" flipH="1">
                    <a:off x="-857937" y="2928925"/>
                    <a:ext cx="2143140" cy="1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" name="TextBox 6"/>
                  <p:cNvSpPr txBox="1"/>
                  <p:nvPr/>
                </p:nvSpPr>
                <p:spPr>
                  <a:xfrm rot="16200000">
                    <a:off x="4720" y="2217716"/>
                    <a:ext cx="604706" cy="2462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Copia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" name="TextBox 7"/>
                  <p:cNvSpPr txBox="1"/>
                  <p:nvPr/>
                </p:nvSpPr>
                <p:spPr>
                  <a:xfrm rot="10800000">
                    <a:off x="341442" y="1893145"/>
                    <a:ext cx="338545" cy="609671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499725" y="1783378"/>
                    <a:ext cx="357190" cy="11310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1.0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 rot="16200000">
                    <a:off x="12604" y="3152827"/>
                    <a:ext cx="617512" cy="2462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Gypsy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 rot="10800000">
                    <a:off x="356846" y="3173702"/>
                    <a:ext cx="338555" cy="469604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499725" y="2914185"/>
                    <a:ext cx="357190" cy="11310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1.0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 rot="16200000">
                    <a:off x="-1398795" y="5119588"/>
                    <a:ext cx="275396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                                   Class I:</a:t>
                    </a:r>
                  </a:p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 long and short interspersed nuclear element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4" name="直接连接符 13"/>
                  <p:cNvCxnSpPr/>
                  <p:nvPr/>
                </p:nvCxnSpPr>
                <p:spPr>
                  <a:xfrm rot="5400000">
                    <a:off x="-857937" y="5357818"/>
                    <a:ext cx="2143140" cy="1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" name="TextBox 14"/>
                  <p:cNvSpPr txBox="1"/>
                  <p:nvPr/>
                </p:nvSpPr>
                <p:spPr>
                  <a:xfrm rot="16200000">
                    <a:off x="-605779" y="7151920"/>
                    <a:ext cx="1181044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         Class II : </a:t>
                    </a:r>
                  </a:p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DNA transposon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6" name="直接连接符 15"/>
                  <p:cNvCxnSpPr/>
                  <p:nvPr/>
                </p:nvCxnSpPr>
                <p:spPr>
                  <a:xfrm rot="16200000" flipH="1">
                    <a:off x="-354415" y="7374446"/>
                    <a:ext cx="1135578" cy="523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" name="TextBox 16"/>
                  <p:cNvSpPr txBox="1"/>
                  <p:nvPr/>
                </p:nvSpPr>
                <p:spPr>
                  <a:xfrm rot="16200000">
                    <a:off x="18989" y="4646658"/>
                    <a:ext cx="604741" cy="2462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LINEs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 rot="16200000">
                    <a:off x="34225" y="5718244"/>
                    <a:ext cx="604749" cy="2462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SINEs</a:t>
                    </a:r>
                    <a:endParaRPr lang="zh-CN" altLang="en-US" sz="10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499725" y="6777869"/>
                    <a:ext cx="357190" cy="11310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1.0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499725" y="5391972"/>
                    <a:ext cx="357190" cy="11310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1.0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499725" y="4257355"/>
                    <a:ext cx="357190" cy="113107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1.0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2" name="TextBox 21"/>
                  <p:cNvSpPr txBox="1"/>
                  <p:nvPr/>
                </p:nvSpPr>
                <p:spPr>
                  <a:xfrm rot="10800000">
                    <a:off x="356823" y="6958469"/>
                    <a:ext cx="338555" cy="580716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 rot="10800000">
                    <a:off x="356823" y="5595953"/>
                    <a:ext cx="338555" cy="514475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 rot="10800000">
                    <a:off x="356848" y="4460523"/>
                    <a:ext cx="338555" cy="540105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2391720" y="1713838"/>
                    <a:ext cx="357190" cy="11998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 fontAlgn="auto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8</a:t>
                    </a:r>
                  </a:p>
                  <a:p>
                    <a:pPr algn="r" fontAlgn="auto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6</a:t>
                    </a:r>
                  </a:p>
                  <a:p>
                    <a:pPr algn="r" fontAlgn="auto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</a:t>
                    </a:r>
                  </a:p>
                  <a:p>
                    <a:pPr algn="r" fontAlgn="auto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</a:p>
                  <a:p>
                    <a:pPr algn="r" fontAlgn="auto">
                      <a:lnSpc>
                        <a:spcPts val="9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9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0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 rot="10800000">
                    <a:off x="2232148" y="2038469"/>
                    <a:ext cx="338545" cy="526287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H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 rot="10800000">
                    <a:off x="2232148" y="3181475"/>
                    <a:ext cx="338545" cy="533916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H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 rot="10800000">
                    <a:off x="2232148" y="4538795"/>
                    <a:ext cx="338545" cy="533364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H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 rot="10800000">
                    <a:off x="2232148" y="5681801"/>
                    <a:ext cx="338545" cy="537183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H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 rot="10800000">
                    <a:off x="2232142" y="7034125"/>
                    <a:ext cx="338555" cy="576481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just"/>
                    <a:r>
                      <a:rPr lang="en-US" altLang="zh-CN" sz="1000" b="1" dirty="0">
                        <a:latin typeface="Times New Roman" pitchFamily="18" charset="0"/>
                        <a:cs typeface="Times New Roman" pitchFamily="18" charset="0"/>
                      </a:rPr>
                      <a:t>mCHG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4283398" y="1734670"/>
                    <a:ext cx="428628" cy="1152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0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32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4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16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08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00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>
                    <a:off x="4283398" y="2888694"/>
                    <a:ext cx="428628" cy="11523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40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32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24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16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08</a:t>
                    </a:r>
                  </a:p>
                  <a:p>
                    <a:pPr algn="r" fontAlgn="auto">
                      <a:lnSpc>
                        <a:spcPts val="700"/>
                      </a:lnSpc>
                    </a:pPr>
                    <a:endParaRPr lang="en-US" altLang="zh-CN" sz="10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pPr algn="r" fontAlgn="auto">
                      <a:lnSpc>
                        <a:spcPts val="700"/>
                      </a:lnSpc>
                    </a:pP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0.00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714325" y="3889733"/>
                    <a:ext cx="5429104" cy="25391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50" dirty="0">
                        <a:latin typeface="Times New Roman" pitchFamily="18" charset="0"/>
                        <a:cs typeface="Times New Roman" pitchFamily="18" charset="0"/>
                      </a:rPr>
                      <a:t> </a:t>
                    </a: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-2kb    start         end    +2kb             -2kb      start        end     +2kb              -2kb     start        end   +2kb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714325" y="6389882"/>
                    <a:ext cx="5429104" cy="25391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50" dirty="0">
                        <a:latin typeface="Times New Roman" pitchFamily="18" charset="0"/>
                        <a:cs typeface="Times New Roman" pitchFamily="18" charset="0"/>
                      </a:rPr>
                      <a:t> </a:t>
                    </a: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-2kb    start        end    +2kb              -2kb      start       end     +2kb               -2kb     start       end    +2kb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714325" y="7787237"/>
                    <a:ext cx="5429104" cy="25391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50" dirty="0">
                        <a:latin typeface="Times New Roman" pitchFamily="18" charset="0"/>
                        <a:cs typeface="Times New Roman" pitchFamily="18" charset="0"/>
                      </a:rPr>
                      <a:t> </a:t>
                    </a:r>
                    <a:r>
                      <a:rPr lang="en-US" altLang="zh-CN" sz="1000" dirty="0">
                        <a:latin typeface="Times New Roman" pitchFamily="18" charset="0"/>
                        <a:cs typeface="Times New Roman" pitchFamily="18" charset="0"/>
                      </a:rPr>
                      <a:t>-2kb    start         end    +2kb             -2kb     start        end     +2kb               -2kb      start       end   +2kb</a:t>
                    </a:r>
                    <a:endParaRPr lang="zh-CN" altLang="en-US" sz="10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56" name="TextBox 55"/>
                <p:cNvSpPr txBox="1"/>
                <p:nvPr/>
              </p:nvSpPr>
              <p:spPr>
                <a:xfrm>
                  <a:off x="6572943" y="803901"/>
                  <a:ext cx="569970" cy="400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Leaf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Callus</a:t>
                  </a: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6573123" y="3314694"/>
                  <a:ext cx="569986" cy="400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Leaf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Callus</a:t>
                  </a: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6572924" y="4451441"/>
                  <a:ext cx="641407" cy="400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Leaf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Callus</a:t>
                  </a: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6572680" y="5846248"/>
                  <a:ext cx="641383" cy="400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Leaf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Callus</a:t>
                  </a: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6573033" y="1922427"/>
                  <a:ext cx="569978" cy="400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Leaf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  <a:p>
                  <a:pPr>
                    <a:lnSpc>
                      <a:spcPts val="1200"/>
                    </a:lnSpc>
                  </a:pPr>
                  <a:r>
                    <a:rPr lang="en-US" altLang="zh-CN" sz="1000" dirty="0">
                      <a:latin typeface="Times New Roman" pitchFamily="18" charset="0"/>
                      <a:cs typeface="Times New Roman" pitchFamily="18" charset="0"/>
                    </a:rPr>
                    <a:t>Callus</a:t>
                  </a:r>
                </a:p>
              </p:txBody>
            </p:sp>
          </p:grpSp>
          <p:sp>
            <p:nvSpPr>
              <p:cNvPr id="64" name="TextBox 63"/>
              <p:cNvSpPr txBox="1"/>
              <p:nvPr/>
            </p:nvSpPr>
            <p:spPr>
              <a:xfrm rot="10800000">
                <a:off x="5356749" y="301552"/>
                <a:ext cx="338545" cy="52247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just"/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mCHH</a:t>
                </a:r>
                <a:endParaRPr lang="zh-CN" alt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 rot="10800000">
                <a:off x="5356749" y="1433683"/>
                <a:ext cx="338545" cy="53335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just"/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mCHH</a:t>
                </a:r>
                <a:endParaRPr lang="zh-CN" alt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 rot="10800000">
                <a:off x="5356749" y="2791062"/>
                <a:ext cx="338545" cy="53329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just"/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mCHH</a:t>
                </a:r>
                <a:endParaRPr lang="zh-CN" alt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 rot="10800000">
                <a:off x="5356750" y="3895859"/>
                <a:ext cx="338545" cy="53393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just"/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mCHH</a:t>
                </a:r>
                <a:endParaRPr lang="zh-CN" alt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 rot="10800000">
                <a:off x="5334159" y="5307808"/>
                <a:ext cx="338545" cy="51687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just"/>
                <a:r>
                  <a:rPr lang="en-US" altLang="zh-CN" sz="1000" b="1" dirty="0">
                    <a:latin typeface="Times New Roman" pitchFamily="18" charset="0"/>
                    <a:cs typeface="Times New Roman" pitchFamily="18" charset="0"/>
                  </a:rPr>
                  <a:t>mCHH</a:t>
                </a:r>
                <a:endParaRPr lang="zh-CN" alt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43" name="TextBox 35"/>
            <p:cNvSpPr txBox="1"/>
            <p:nvPr/>
          </p:nvSpPr>
          <p:spPr>
            <a:xfrm>
              <a:off x="8658" y="3975"/>
              <a:ext cx="675" cy="1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0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32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4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16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8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35"/>
            <p:cNvSpPr txBox="1"/>
            <p:nvPr/>
          </p:nvSpPr>
          <p:spPr>
            <a:xfrm>
              <a:off x="8658" y="5755"/>
              <a:ext cx="675" cy="1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0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32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4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16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8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35"/>
            <p:cNvSpPr txBox="1"/>
            <p:nvPr/>
          </p:nvSpPr>
          <p:spPr>
            <a:xfrm>
              <a:off x="8658" y="7993"/>
              <a:ext cx="675" cy="1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0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32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4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16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8</a:t>
              </a:r>
            </a:p>
            <a:p>
              <a:pPr algn="r" fontAlgn="auto">
                <a:lnSpc>
                  <a:spcPts val="7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7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24"/>
            <p:cNvSpPr txBox="1"/>
            <p:nvPr/>
          </p:nvSpPr>
          <p:spPr>
            <a:xfrm>
              <a:off x="5679" y="1793"/>
              <a:ext cx="563" cy="1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8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6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24"/>
            <p:cNvSpPr txBox="1"/>
            <p:nvPr/>
          </p:nvSpPr>
          <p:spPr>
            <a:xfrm>
              <a:off x="5679" y="3945"/>
              <a:ext cx="563" cy="1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8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6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24"/>
            <p:cNvSpPr txBox="1"/>
            <p:nvPr/>
          </p:nvSpPr>
          <p:spPr>
            <a:xfrm>
              <a:off x="5679" y="5755"/>
              <a:ext cx="563" cy="1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8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6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24"/>
            <p:cNvSpPr txBox="1"/>
            <p:nvPr/>
          </p:nvSpPr>
          <p:spPr>
            <a:xfrm>
              <a:off x="5679" y="7964"/>
              <a:ext cx="563" cy="19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8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6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4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2</a:t>
              </a:r>
            </a:p>
            <a:p>
              <a:pPr algn="r" fontAlgn="auto">
                <a:lnSpc>
                  <a:spcPts val="900"/>
                </a:lnSpc>
              </a:pPr>
              <a:endParaRPr lang="en-US" altLang="zh-CN" sz="1000" dirty="0">
                <a:latin typeface="Times New Roman" pitchFamily="18" charset="0"/>
                <a:cs typeface="Times New Roman" pitchFamily="18" charset="0"/>
              </a:endParaRPr>
            </a:p>
            <a:p>
              <a:pPr algn="r" fontAlgn="auto">
                <a:lnSpc>
                  <a:spcPts val="900"/>
                </a:lnSpc>
              </a:pP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0.0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0" y="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51520" y="6237312"/>
            <a:ext cx="86409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. S1 Characterization of DNA methylation patterns along different classes of TEs in leaf and leaf-derived callus.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The average enrichment of mC, mCHG and mCHH within the TE body and in the 2 kb sequences upstream (-2 kb) or downstream (+2 kb) were profiled. The red line represents leaf and the blue line represents callus.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06A4158A-0504-4B42-93CA-A4B874003A3B}"/>
              </a:ext>
            </a:extLst>
          </p:cNvPr>
          <p:cNvGrpSpPr/>
          <p:nvPr/>
        </p:nvGrpSpPr>
        <p:grpSpPr>
          <a:xfrm>
            <a:off x="825474" y="3346461"/>
            <a:ext cx="7175550" cy="2530811"/>
            <a:chOff x="825474" y="191708"/>
            <a:chExt cx="7175550" cy="2737226"/>
          </a:xfrm>
        </p:grpSpPr>
        <p:pic>
          <p:nvPicPr>
            <p:cNvPr id="4" name="图片 3" descr="gene_CHH2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857752" y="413151"/>
              <a:ext cx="3143272" cy="2354992"/>
            </a:xfrm>
            <a:prstGeom prst="rect">
              <a:avLst/>
            </a:prstGeom>
          </p:spPr>
        </p:pic>
        <p:sp>
          <p:nvSpPr>
            <p:cNvPr id="8" name="TextBox 6"/>
            <p:cNvSpPr txBox="1">
              <a:spLocks noChangeArrowheads="1"/>
            </p:cNvSpPr>
            <p:nvPr/>
          </p:nvSpPr>
          <p:spPr bwMode="auto">
            <a:xfrm rot="16200000">
              <a:off x="-51619" y="1398494"/>
              <a:ext cx="2000249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Expression difference (log</a:t>
              </a:r>
              <a:r>
                <a:rPr lang="en-US" altLang="zh-CN" sz="1000" b="1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FC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6"/>
            <p:cNvSpPr txBox="1">
              <a:spLocks noChangeArrowheads="1"/>
            </p:cNvSpPr>
            <p:nvPr/>
          </p:nvSpPr>
          <p:spPr bwMode="auto">
            <a:xfrm rot="16200000">
              <a:off x="3766345" y="1398494"/>
              <a:ext cx="2000249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Expression difference (log</a:t>
              </a:r>
              <a:r>
                <a:rPr lang="en-US" altLang="zh-CN" sz="1000" b="1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FC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矩形 12"/>
            <p:cNvSpPr>
              <a:spLocks noChangeArrowheads="1"/>
            </p:cNvSpPr>
            <p:nvPr/>
          </p:nvSpPr>
          <p:spPr bwMode="auto">
            <a:xfrm>
              <a:off x="5429256" y="539573"/>
              <a:ext cx="65915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40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19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矩形 12"/>
            <p:cNvSpPr>
              <a:spLocks noChangeArrowheads="1"/>
            </p:cNvSpPr>
            <p:nvPr/>
          </p:nvSpPr>
          <p:spPr bwMode="auto">
            <a:xfrm>
              <a:off x="6929454" y="539573"/>
              <a:ext cx="5950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27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46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矩形 12"/>
            <p:cNvSpPr>
              <a:spLocks noChangeArrowheads="1"/>
            </p:cNvSpPr>
            <p:nvPr/>
          </p:nvSpPr>
          <p:spPr bwMode="auto">
            <a:xfrm>
              <a:off x="5429256" y="2182647"/>
              <a:ext cx="723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05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62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矩形 12"/>
            <p:cNvSpPr>
              <a:spLocks noChangeArrowheads="1"/>
            </p:cNvSpPr>
            <p:nvPr/>
          </p:nvSpPr>
          <p:spPr bwMode="auto">
            <a:xfrm>
              <a:off x="6929454" y="2182647"/>
              <a:ext cx="5950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28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38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0" name="图片 29" descr="gene_CHG3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071538" y="428604"/>
              <a:ext cx="3101856" cy="2305761"/>
            </a:xfrm>
            <a:prstGeom prst="rect">
              <a:avLst/>
            </a:prstGeom>
          </p:spPr>
        </p:pic>
        <p:sp>
          <p:nvSpPr>
            <p:cNvPr id="31" name="矩形 12"/>
            <p:cNvSpPr>
              <a:spLocks noChangeArrowheads="1"/>
            </p:cNvSpPr>
            <p:nvPr/>
          </p:nvSpPr>
          <p:spPr bwMode="auto">
            <a:xfrm>
              <a:off x="1643042" y="571480"/>
              <a:ext cx="65915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93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381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矩形 12"/>
            <p:cNvSpPr>
              <a:spLocks noChangeArrowheads="1"/>
            </p:cNvSpPr>
            <p:nvPr/>
          </p:nvSpPr>
          <p:spPr bwMode="auto">
            <a:xfrm>
              <a:off x="3214678" y="571480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4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矩形 12"/>
            <p:cNvSpPr>
              <a:spLocks noChangeArrowheads="1"/>
            </p:cNvSpPr>
            <p:nvPr/>
          </p:nvSpPr>
          <p:spPr bwMode="auto">
            <a:xfrm>
              <a:off x="3214678" y="2111209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4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4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矩形 12"/>
            <p:cNvSpPr>
              <a:spLocks noChangeArrowheads="1"/>
            </p:cNvSpPr>
            <p:nvPr/>
          </p:nvSpPr>
          <p:spPr bwMode="auto">
            <a:xfrm>
              <a:off x="1643042" y="2111209"/>
              <a:ext cx="65915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98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67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8"/>
            <p:cNvSpPr txBox="1">
              <a:spLocks noChangeArrowheads="1"/>
            </p:cNvSpPr>
            <p:nvPr/>
          </p:nvSpPr>
          <p:spPr bwMode="auto">
            <a:xfrm>
              <a:off x="2143108" y="2682713"/>
              <a:ext cx="53578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mCHG difference                                                                                           mCHH differenc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195736" y="191708"/>
              <a:ext cx="990012" cy="299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itchFamily="18" charset="0"/>
                  <a:cs typeface="Times New Roman" pitchFamily="18" charset="0"/>
                </a:rPr>
                <a:t> Gene body         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3D54D19B-2AEF-413B-A35B-4BB26323D363}"/>
              </a:ext>
            </a:extLst>
          </p:cNvPr>
          <p:cNvGrpSpPr/>
          <p:nvPr/>
        </p:nvGrpSpPr>
        <p:grpSpPr>
          <a:xfrm>
            <a:off x="857225" y="602412"/>
            <a:ext cx="7155155" cy="2520114"/>
            <a:chOff x="925189" y="2846483"/>
            <a:chExt cx="7019054" cy="2725657"/>
          </a:xfrm>
        </p:grpSpPr>
        <p:pic>
          <p:nvPicPr>
            <p:cNvPr id="5" name="图片 4" descr="promoter_CHH2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857752" y="3082273"/>
              <a:ext cx="3086491" cy="23040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299642" y="2846483"/>
              <a:ext cx="873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itchFamily="18" charset="0"/>
                  <a:cs typeface="Times New Roman" pitchFamily="18" charset="0"/>
                </a:rPr>
                <a:t> Promoter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6"/>
            <p:cNvSpPr txBox="1">
              <a:spLocks noChangeArrowheads="1"/>
            </p:cNvSpPr>
            <p:nvPr/>
          </p:nvSpPr>
          <p:spPr bwMode="auto">
            <a:xfrm rot="16200000">
              <a:off x="48096" y="4007809"/>
              <a:ext cx="2000249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Expression difference (log</a:t>
              </a:r>
              <a:r>
                <a:rPr lang="en-US" altLang="zh-CN" sz="1000" b="1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FC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6"/>
            <p:cNvSpPr txBox="1">
              <a:spLocks noChangeArrowheads="1"/>
            </p:cNvSpPr>
            <p:nvPr/>
          </p:nvSpPr>
          <p:spPr bwMode="auto">
            <a:xfrm rot="16200000">
              <a:off x="3762291" y="4007809"/>
              <a:ext cx="2000249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Expression difference (log</a:t>
              </a:r>
              <a:r>
                <a:rPr lang="en-US" altLang="zh-CN" sz="1000" b="1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FC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8"/>
            <p:cNvSpPr txBox="1">
              <a:spLocks noChangeArrowheads="1"/>
            </p:cNvSpPr>
            <p:nvPr/>
          </p:nvSpPr>
          <p:spPr bwMode="auto">
            <a:xfrm>
              <a:off x="2143108" y="5325919"/>
              <a:ext cx="53578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mCHG difference                                                                                           mCHH differenc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矩形 12"/>
            <p:cNvSpPr>
              <a:spLocks noChangeArrowheads="1"/>
            </p:cNvSpPr>
            <p:nvPr/>
          </p:nvSpPr>
          <p:spPr bwMode="auto">
            <a:xfrm>
              <a:off x="5429256" y="3254217"/>
              <a:ext cx="723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95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523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矩形 12"/>
            <p:cNvSpPr>
              <a:spLocks noChangeArrowheads="1"/>
            </p:cNvSpPr>
            <p:nvPr/>
          </p:nvSpPr>
          <p:spPr bwMode="auto">
            <a:xfrm>
              <a:off x="6913241" y="3254217"/>
              <a:ext cx="65915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86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82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矩形 12"/>
            <p:cNvSpPr>
              <a:spLocks noChangeArrowheads="1"/>
            </p:cNvSpPr>
            <p:nvPr/>
          </p:nvSpPr>
          <p:spPr bwMode="auto">
            <a:xfrm>
              <a:off x="5429256" y="4897291"/>
              <a:ext cx="723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326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551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矩形 12"/>
            <p:cNvSpPr>
              <a:spLocks noChangeArrowheads="1"/>
            </p:cNvSpPr>
            <p:nvPr/>
          </p:nvSpPr>
          <p:spPr bwMode="auto">
            <a:xfrm>
              <a:off x="6929454" y="4897291"/>
              <a:ext cx="5950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7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91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7" name="图片 36" descr="promoter_CHG3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095781" y="3092438"/>
              <a:ext cx="3075215" cy="2304000"/>
            </a:xfrm>
            <a:prstGeom prst="rect">
              <a:avLst/>
            </a:prstGeom>
          </p:spPr>
        </p:pic>
        <p:sp>
          <p:nvSpPr>
            <p:cNvPr id="38" name="矩形 12"/>
            <p:cNvSpPr>
              <a:spLocks noChangeArrowheads="1"/>
            </p:cNvSpPr>
            <p:nvPr/>
          </p:nvSpPr>
          <p:spPr bwMode="auto">
            <a:xfrm>
              <a:off x="1643042" y="3214686"/>
              <a:ext cx="723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89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539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矩形 12"/>
            <p:cNvSpPr>
              <a:spLocks noChangeArrowheads="1"/>
            </p:cNvSpPr>
            <p:nvPr/>
          </p:nvSpPr>
          <p:spPr bwMode="auto">
            <a:xfrm>
              <a:off x="3143240" y="3214686"/>
              <a:ext cx="53091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1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矩形 12"/>
            <p:cNvSpPr>
              <a:spLocks noChangeArrowheads="1"/>
            </p:cNvSpPr>
            <p:nvPr/>
          </p:nvSpPr>
          <p:spPr bwMode="auto">
            <a:xfrm>
              <a:off x="1643042" y="4825853"/>
              <a:ext cx="723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55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294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矩形 12"/>
            <p:cNvSpPr>
              <a:spLocks noChangeArrowheads="1"/>
            </p:cNvSpPr>
            <p:nvPr/>
          </p:nvSpPr>
          <p:spPr bwMode="auto">
            <a:xfrm>
              <a:off x="3119709" y="4857760"/>
              <a:ext cx="5950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zh-CN" altLang="en-US" sz="10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4</a:t>
              </a:r>
              <a:r>
                <a:rPr lang="en-US" altLang="zh-CN" sz="1000" b="1" dirty="0">
                  <a:latin typeface="Times New Roman" pitchFamily="18" charset="0"/>
                  <a:cs typeface="Times New Roman" pitchFamily="18" charset="0"/>
                </a:rPr>
                <a:t>/19)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64696" y="6001725"/>
            <a:ext cx="864096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Fig. S2  Association analysis between DNA methylation and gene expression level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itchFamily="18" charset="0"/>
              </a:rPr>
              <a:t>in the CHG and CHH context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The x-axis is the change of mCHG and mCHH. Only the genes with |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itchFamily="18" charset="0"/>
              </a:rPr>
              <a:t>ΔmCHG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|≥0.15 and |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itchFamily="18" charset="0"/>
              </a:rPr>
              <a:t>ΔmCHH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|≥0.15 are plotted</a:t>
            </a:r>
            <a:r>
              <a:rPr lang="el-GR" altLang="zh-CN" sz="1000" dirty="0">
                <a:latin typeface="Times New Roman" panose="02020603050405020304" pitchFamily="18" charset="0"/>
                <a:cs typeface="Times New Roman" pitchFamily="18" charset="0"/>
              </a:rPr>
              <a:t>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The y-axis represents the gene expression difference (log</a:t>
            </a:r>
            <a:r>
              <a:rPr lang="en-US" altLang="zh-CN" sz="1000" baseline="-25000" dirty="0">
                <a:latin typeface="Times New Roman" panose="02020603050405020304" pitchFamily="18" charset="0"/>
                <a:cs typeface="Times New Roman" pitchFamily="18" charset="0"/>
              </a:rPr>
              <a:t>2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FC). The red points are the DEGs satisfying |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itchFamily="18" charset="0"/>
              </a:rPr>
              <a:t>ΔmCHG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| or |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itchFamily="18" charset="0"/>
              </a:rPr>
              <a:t>ΔmCHH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|≥0.15, |log</a:t>
            </a:r>
            <a:r>
              <a:rPr lang="en-US" altLang="zh-CN" sz="1000" baseline="-25000" dirty="0">
                <a:latin typeface="Times New Roman" panose="02020603050405020304" pitchFamily="18" charset="0"/>
                <a:cs typeface="Times New Roman" pitchFamily="18" charset="0"/>
              </a:rPr>
              <a:t>2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FC|≥1,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itchFamily="18" charset="0"/>
              </a:rPr>
              <a:t>P</a:t>
            </a:r>
            <a:r>
              <a:rPr lang="en-US" altLang="zh-CN" sz="1000" i="1" baseline="-25000" dirty="0">
                <a:latin typeface="Times New Roman" panose="02020603050405020304" pitchFamily="18" charset="0"/>
                <a:cs typeface="Times New Roman" pitchFamily="18" charset="0"/>
              </a:rPr>
              <a:t>adj</a:t>
            </a:r>
            <a:r>
              <a:rPr lang="en-US" altLang="zh-CN" sz="1000" dirty="0">
                <a:latin typeface="Times New Roman" panose="02020603050405020304" pitchFamily="18" charset="0"/>
                <a:cs typeface="Times New Roman" pitchFamily="18" charset="0"/>
              </a:rPr>
              <a:t>&lt;0.05, and the number in black and red refer to the number of black and red points in each quadrant, respectively. </a:t>
            </a:r>
            <a:endParaRPr lang="zh-CN" altLang="en-US" sz="1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43" name="TextBox 3"/>
          <p:cNvSpPr txBox="1"/>
          <p:nvPr/>
        </p:nvSpPr>
        <p:spPr>
          <a:xfrm>
            <a:off x="0" y="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23">
            <a:extLst>
              <a:ext uri="{FF2B5EF4-FFF2-40B4-BE49-F238E27FC236}">
                <a16:creationId xmlns:a16="http://schemas.microsoft.com/office/drawing/2014/main" xmlns="" id="{66EDC408-2BFB-47D3-9B59-93FB41B56CBE}"/>
              </a:ext>
            </a:extLst>
          </p:cNvPr>
          <p:cNvSpPr txBox="1"/>
          <p:nvPr/>
        </p:nvSpPr>
        <p:spPr>
          <a:xfrm>
            <a:off x="466689" y="476672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0C1DD5AC-3913-4D5B-B67F-BD35B6F31244}"/>
              </a:ext>
            </a:extLst>
          </p:cNvPr>
          <p:cNvSpPr txBox="1"/>
          <p:nvPr/>
        </p:nvSpPr>
        <p:spPr>
          <a:xfrm>
            <a:off x="6088411" y="585719"/>
            <a:ext cx="8906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Promoter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23">
            <a:extLst>
              <a:ext uri="{FF2B5EF4-FFF2-40B4-BE49-F238E27FC236}">
                <a16:creationId xmlns:a16="http://schemas.microsoft.com/office/drawing/2014/main" xmlns="" id="{04F7848D-3FC2-4958-B154-7EB658F675FC}"/>
              </a:ext>
            </a:extLst>
          </p:cNvPr>
          <p:cNvSpPr txBox="1"/>
          <p:nvPr/>
        </p:nvSpPr>
        <p:spPr>
          <a:xfrm>
            <a:off x="4499992" y="483637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23">
            <a:extLst>
              <a:ext uri="{FF2B5EF4-FFF2-40B4-BE49-F238E27FC236}">
                <a16:creationId xmlns:a16="http://schemas.microsoft.com/office/drawing/2014/main" xmlns="" id="{29AD0156-57A0-47A5-AB01-3E25E30C330E}"/>
              </a:ext>
            </a:extLst>
          </p:cNvPr>
          <p:cNvSpPr txBox="1"/>
          <p:nvPr/>
        </p:nvSpPr>
        <p:spPr>
          <a:xfrm>
            <a:off x="467544" y="3184495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23">
            <a:extLst>
              <a:ext uri="{FF2B5EF4-FFF2-40B4-BE49-F238E27FC236}">
                <a16:creationId xmlns:a16="http://schemas.microsoft.com/office/drawing/2014/main" xmlns="" id="{0A349E01-A48F-4F22-B068-1BA5D218922A}"/>
              </a:ext>
            </a:extLst>
          </p:cNvPr>
          <p:cNvSpPr txBox="1"/>
          <p:nvPr/>
        </p:nvSpPr>
        <p:spPr>
          <a:xfrm>
            <a:off x="4502970" y="3193233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1BC75739-BB82-41BF-9D11-24B87DC71F7E}"/>
              </a:ext>
            </a:extLst>
          </p:cNvPr>
          <p:cNvSpPr txBox="1"/>
          <p:nvPr/>
        </p:nvSpPr>
        <p:spPr>
          <a:xfrm>
            <a:off x="6012160" y="3329840"/>
            <a:ext cx="109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Gene body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720" y="6269250"/>
            <a:ext cx="85347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. S3 Gene ontology (GO) enrichment analysis of the up-regulated </a:t>
            </a:r>
            <a:r>
              <a:rPr lang="en-US" altLang="zh-CN" sz="1000" b="1">
                <a:latin typeface="Times New Roman" pitchFamily="18" charset="0"/>
                <a:cs typeface="Times New Roman" pitchFamily="18" charset="0"/>
              </a:rPr>
              <a:t>and down-regulated </a:t>
            </a:r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methlDEGs in leaf-to-callus transition.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The analysis is performed by using the online platform OmicShare tools (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  <a:hlinkClick r:id="rId2"/>
              </a:rPr>
              <a:t>www.omicshare.com/tools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). The top 20 GO terms are displayed.</a:t>
            </a:r>
            <a:endParaRPr lang="zh-CN" alt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-32" y="-24"/>
            <a:ext cx="1103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3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 descr="up_GO.png"/>
          <p:cNvPicPr>
            <a:picLocks noChangeAspect="1"/>
          </p:cNvPicPr>
          <p:nvPr/>
        </p:nvPicPr>
        <p:blipFill rotWithShape="1">
          <a:blip r:embed="rId3" cstate="print"/>
          <a:srcRect l="6403"/>
          <a:stretch/>
        </p:blipFill>
        <p:spPr>
          <a:xfrm>
            <a:off x="3304168" y="294752"/>
            <a:ext cx="5012248" cy="2990232"/>
          </a:xfrm>
          <a:prstGeom prst="rect">
            <a:avLst/>
          </a:prstGeom>
        </p:spPr>
      </p:pic>
      <p:pic>
        <p:nvPicPr>
          <p:cNvPr id="7" name="图片 6" descr="down_GO.png"/>
          <p:cNvPicPr>
            <a:picLocks noChangeAspect="1"/>
          </p:cNvPicPr>
          <p:nvPr/>
        </p:nvPicPr>
        <p:blipFill rotWithShape="1">
          <a:blip r:embed="rId4" cstate="print"/>
          <a:srcRect l="5409"/>
          <a:stretch/>
        </p:blipFill>
        <p:spPr>
          <a:xfrm>
            <a:off x="467544" y="3319087"/>
            <a:ext cx="7836509" cy="2990233"/>
          </a:xfrm>
          <a:prstGeom prst="rect">
            <a:avLst/>
          </a:prstGeom>
        </p:spPr>
      </p:pic>
      <p:sp>
        <p:nvSpPr>
          <p:cNvPr id="8" name="TextBox 23">
            <a:extLst>
              <a:ext uri="{FF2B5EF4-FFF2-40B4-BE49-F238E27FC236}">
                <a16:creationId xmlns:a16="http://schemas.microsoft.com/office/drawing/2014/main" xmlns="" id="{D8809B4C-AF64-4BC0-B338-CB0E14AEA268}"/>
              </a:ext>
            </a:extLst>
          </p:cNvPr>
          <p:cNvSpPr txBox="1"/>
          <p:nvPr/>
        </p:nvSpPr>
        <p:spPr>
          <a:xfrm>
            <a:off x="510378" y="404664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23">
            <a:extLst>
              <a:ext uri="{FF2B5EF4-FFF2-40B4-BE49-F238E27FC236}">
                <a16:creationId xmlns:a16="http://schemas.microsoft.com/office/drawing/2014/main" xmlns="" id="{A6E13838-0E73-48DE-AAF8-34AFD0BE0808}"/>
              </a:ext>
            </a:extLst>
          </p:cNvPr>
          <p:cNvSpPr txBox="1"/>
          <p:nvPr/>
        </p:nvSpPr>
        <p:spPr>
          <a:xfrm>
            <a:off x="511233" y="3337249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4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1520" y="6315038"/>
            <a:ext cx="86409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. S4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Kyoto Encyclopedia of Genes and Genomes (KEGG) enrichment analysis of the up-regulated and down-regulated </a:t>
            </a:r>
            <a:r>
              <a:rPr lang="en-US" altLang="zh-CN" sz="1000" b="1" dirty="0" err="1">
                <a:latin typeface="Times New Roman" pitchFamily="18" charset="0"/>
                <a:cs typeface="Times New Roman" pitchFamily="18" charset="0"/>
              </a:rPr>
              <a:t>methlDEGs</a:t>
            </a:r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 in leaf-to-callus transition.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The analysis is performed by using the online platform OmicShare tools (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  <a:hlinkClick r:id="rId2"/>
              </a:rPr>
              <a:t>www.omicshare.com/tools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). The top 20 KEGG pathway are displayed.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 descr="up_KEGG.png"/>
          <p:cNvPicPr>
            <a:picLocks noChangeAspect="1"/>
          </p:cNvPicPr>
          <p:nvPr/>
        </p:nvPicPr>
        <p:blipFill rotWithShape="1">
          <a:blip r:embed="rId3" cstate="print"/>
          <a:srcRect l="6891"/>
          <a:stretch/>
        </p:blipFill>
        <p:spPr>
          <a:xfrm>
            <a:off x="2699792" y="351557"/>
            <a:ext cx="3943909" cy="2861419"/>
          </a:xfrm>
          <a:prstGeom prst="rect">
            <a:avLst/>
          </a:prstGeom>
        </p:spPr>
      </p:pic>
      <p:pic>
        <p:nvPicPr>
          <p:cNvPr id="7" name="图片 6" descr="down_KEGG.png"/>
          <p:cNvPicPr>
            <a:picLocks noChangeAspect="1"/>
          </p:cNvPicPr>
          <p:nvPr/>
        </p:nvPicPr>
        <p:blipFill rotWithShape="1">
          <a:blip r:embed="rId4" cstate="print"/>
          <a:srcRect l="5042"/>
          <a:stretch/>
        </p:blipFill>
        <p:spPr>
          <a:xfrm>
            <a:off x="2126438" y="3284984"/>
            <a:ext cx="4517264" cy="2961547"/>
          </a:xfrm>
          <a:prstGeom prst="rect">
            <a:avLst/>
          </a:prstGeom>
        </p:spPr>
      </p:pic>
      <p:sp>
        <p:nvSpPr>
          <p:cNvPr id="8" name="TextBox 23">
            <a:extLst>
              <a:ext uri="{FF2B5EF4-FFF2-40B4-BE49-F238E27FC236}">
                <a16:creationId xmlns:a16="http://schemas.microsoft.com/office/drawing/2014/main" xmlns="" id="{71B1BA64-8A60-459B-8618-2B6F38C19717}"/>
              </a:ext>
            </a:extLst>
          </p:cNvPr>
          <p:cNvSpPr txBox="1"/>
          <p:nvPr/>
        </p:nvSpPr>
        <p:spPr>
          <a:xfrm>
            <a:off x="1621679" y="332656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23">
            <a:extLst>
              <a:ext uri="{FF2B5EF4-FFF2-40B4-BE49-F238E27FC236}">
                <a16:creationId xmlns:a16="http://schemas.microsoft.com/office/drawing/2014/main" xmlns="" id="{117B4576-FA37-4413-87E2-0EC5F312E453}"/>
              </a:ext>
            </a:extLst>
          </p:cNvPr>
          <p:cNvSpPr txBox="1"/>
          <p:nvPr/>
        </p:nvSpPr>
        <p:spPr>
          <a:xfrm>
            <a:off x="1622534" y="3337249"/>
            <a:ext cx="357178" cy="307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0" y="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. S5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 descr="附图IGV图.bmp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363181" y="257042"/>
            <a:ext cx="6209215" cy="574372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520" y="6150138"/>
            <a:ext cx="86409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. S5  Correlation between DNA methylation level and gene expression level of the genes related to callus formation and regeneration.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The IGV browser shots showing the distribution of DNA methylation along the genic and promoter sequences of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FvePLT5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FveRAP2.6L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 FveIAA14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FveLOG4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FveWOX14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. The blue box indicates the differentially methylated region between leaf and leaf-derived callus, and the brown arrow represents the direction of gene transcription.</a:t>
            </a:r>
            <a:endParaRPr lang="zh-CN" altLang="zh-CN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8</TotalTime>
  <Words>646</Words>
  <Application>Microsoft Office PowerPoint</Application>
  <PresentationFormat>全屏显示(4:3)</PresentationFormat>
  <Paragraphs>228</Paragraphs>
  <Slides>5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udecai</cp:lastModifiedBy>
  <cp:revision>697</cp:revision>
  <dcterms:created xsi:type="dcterms:W3CDTF">2020-09-21T02:56:00Z</dcterms:created>
  <dcterms:modified xsi:type="dcterms:W3CDTF">2021-10-17T01:01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